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46"/>
    <p:restoredTop sz="96291"/>
  </p:normalViewPr>
  <p:slideViewPr>
    <p:cSldViewPr snapToGrid="0" snapToObjects="1">
      <p:cViewPr varScale="1">
        <p:scale>
          <a:sx n="85" d="100"/>
          <a:sy n="85" d="100"/>
        </p:scale>
        <p:origin x="30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436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5523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8716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3005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184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2992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0584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7673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647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105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4974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FC212-B5CD-E243-BC29-A3759B2C60DB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4765D-39E3-304D-B589-854AB81A24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184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9062DA56-DE59-0744-9446-2653164D96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3714636"/>
              </p:ext>
            </p:extLst>
          </p:nvPr>
        </p:nvGraphicFramePr>
        <p:xfrm>
          <a:off x="400149" y="561271"/>
          <a:ext cx="6027153" cy="913254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829359">
                  <a:extLst>
                    <a:ext uri="{9D8B030D-6E8A-4147-A177-3AD203B41FA5}">
                      <a16:colId xmlns:a16="http://schemas.microsoft.com/office/drawing/2014/main" val="3542537923"/>
                    </a:ext>
                  </a:extLst>
                </a:gridCol>
                <a:gridCol w="829359">
                  <a:extLst>
                    <a:ext uri="{9D8B030D-6E8A-4147-A177-3AD203B41FA5}">
                      <a16:colId xmlns:a16="http://schemas.microsoft.com/office/drawing/2014/main" val="138115084"/>
                    </a:ext>
                  </a:extLst>
                </a:gridCol>
                <a:gridCol w="829359">
                  <a:extLst>
                    <a:ext uri="{9D8B030D-6E8A-4147-A177-3AD203B41FA5}">
                      <a16:colId xmlns:a16="http://schemas.microsoft.com/office/drawing/2014/main" val="298229758"/>
                    </a:ext>
                  </a:extLst>
                </a:gridCol>
                <a:gridCol w="829359">
                  <a:extLst>
                    <a:ext uri="{9D8B030D-6E8A-4147-A177-3AD203B41FA5}">
                      <a16:colId xmlns:a16="http://schemas.microsoft.com/office/drawing/2014/main" val="1799774835"/>
                    </a:ext>
                  </a:extLst>
                </a:gridCol>
                <a:gridCol w="1050999">
                  <a:extLst>
                    <a:ext uri="{9D8B030D-6E8A-4147-A177-3AD203B41FA5}">
                      <a16:colId xmlns:a16="http://schemas.microsoft.com/office/drawing/2014/main" val="470943394"/>
                    </a:ext>
                  </a:extLst>
                </a:gridCol>
                <a:gridCol w="829359">
                  <a:extLst>
                    <a:ext uri="{9D8B030D-6E8A-4147-A177-3AD203B41FA5}">
                      <a16:colId xmlns:a16="http://schemas.microsoft.com/office/drawing/2014/main" val="219607362"/>
                    </a:ext>
                  </a:extLst>
                </a:gridCol>
                <a:gridCol w="829359">
                  <a:extLst>
                    <a:ext uri="{9D8B030D-6E8A-4147-A177-3AD203B41FA5}">
                      <a16:colId xmlns:a16="http://schemas.microsoft.com/office/drawing/2014/main" val="1809914880"/>
                    </a:ext>
                  </a:extLst>
                </a:gridCol>
              </a:tblGrid>
              <a:tr h="144480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m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efficients</a:t>
                      </a:r>
                      <a:endParaRPr lang="en-GB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 Coefficients</a:t>
                      </a:r>
                      <a:endParaRPr lang="en-GB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1000" i="1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endParaRPr lang="en-GB" sz="1000" b="0" i="1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sz="1000" i="1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lang="en-GB" sz="1000" b="0" i="1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0964113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WT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01 </a:t>
                      </a:r>
                      <a:endParaRPr lang="en-GB" altLang="ja-JP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58736146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900" u="none" strike="noStrike" baseline="30000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82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9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48020086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3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132933798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8.07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777089143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1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9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52768192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8.89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536416007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lue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2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7 </a:t>
                      </a:r>
                      <a:endParaRPr lang="en-GB" altLang="ja-JP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677767812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reen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84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750677526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Red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6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1.59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547739093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55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062794405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900" u="none" strike="noStrike" baseline="30000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81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9.45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040966835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86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248177936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7.88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656481389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54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6</a:t>
                      </a:r>
                      <a:endParaRPr lang="en-GB" altLang="ja-JP" sz="1000" b="0" i="0" u="none" strike="noStrike" noProof="0">
                        <a:solidFill>
                          <a:srgbClr val="F0324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717330990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9.96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301572038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lue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52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909612286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reen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9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1438529260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Red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49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6.08 </a:t>
                      </a:r>
                      <a:endParaRPr lang="en-GB" altLang="ja-JP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7356161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KS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89 </a:t>
                      </a:r>
                      <a:endParaRPr lang="en-GB" altLang="ja-JP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85844807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900" u="none" strike="noStrike" baseline="30000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61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2 </a:t>
                      </a:r>
                      <a:endParaRPr lang="en-GB" altLang="ja-JP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5</a:t>
                      </a:r>
                      <a:endParaRPr lang="en-GB" altLang="ja-JP" sz="1000" b="0" i="0" u="none" strike="noStrike" noProof="0">
                        <a:solidFill>
                          <a:srgbClr val="F0324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711610029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138054090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1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15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778865421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1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10</a:t>
                      </a:r>
                      <a:endParaRPr lang="en-GB" altLang="ja-JP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1972106386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5.61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1535814120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lue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5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251509997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reen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61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71283899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Red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45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2.30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027729270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8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91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048638606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900" u="none" strike="noStrike" baseline="30000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80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1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78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4239737349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94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003196783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2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66</a:t>
                      </a:r>
                      <a:endParaRPr lang="en-GB" altLang="ja-JP" sz="1000" b="0" i="0" u="none" strike="noStrike" noProof="0">
                        <a:solidFill>
                          <a:srgbClr val="F0324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612885587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4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544124989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2.6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405336859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lue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9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508238764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reen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2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547407078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Red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4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4.54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2300291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GS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6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9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91 </a:t>
                      </a:r>
                      <a:endParaRPr lang="en-GB" altLang="ja-JP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612437590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900" u="none" strike="noStrike" baseline="30000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80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702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1241673225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24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092691986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38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8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880953172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5</a:t>
                      </a: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17</a:t>
                      </a: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11085609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1.2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742312277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lue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26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80579021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reen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48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25602102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Red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5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8.65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1058831089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6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5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585482669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GB" sz="900" u="none" strike="noStrike" baseline="30000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0.77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44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52</a:t>
                      </a:r>
                      <a:endParaRPr lang="en-GB" altLang="ja-JP" sz="1000" b="0" i="0" u="none" strike="noStrike" noProof="0">
                        <a:solidFill>
                          <a:srgbClr val="F0324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660122022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66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1803625051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4.29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3194531551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2</a:t>
                      </a: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900" b="0" i="0" u="none" strike="noStrike" noProof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95</a:t>
                      </a: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855652172"/>
                  </a:ext>
                </a:extLst>
              </a:tr>
              <a:tr h="17166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5.20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1623428183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lue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2292827599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reen)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3 </a:t>
                      </a:r>
                      <a:endParaRPr lang="en-GB" altLang="ja-JP" sz="10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/>
                </a:tc>
                <a:extLst>
                  <a:ext uri="{0D108BD9-81ED-4DB2-BD59-A6C34878D82A}">
                    <a16:rowId xmlns:a16="http://schemas.microsoft.com/office/drawing/2014/main" val="929128591"/>
                  </a:ext>
                </a:extLst>
              </a:tr>
              <a:tr h="162123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GB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Red)</a:t>
                      </a:r>
                      <a:endParaRPr lang="en-GB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36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7.11 </a:t>
                      </a:r>
                      <a:endParaRPr lang="en-GB" altLang="ja-JP" sz="10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GB" altLang="ja-JP" sz="10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GB" altLang="ja-JP" sz="1000" b="0" i="0" u="none" strike="noStrike" noProof="0" dirty="0">
                        <a:solidFill>
                          <a:srgbClr val="E57406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52" marR="7152" marT="715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538102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AA9F405-15AB-5645-9171-D68D04F8CD4E}"/>
              </a:ext>
            </a:extLst>
          </p:cNvPr>
          <p:cNvSpPr txBox="1"/>
          <p:nvPr/>
        </p:nvSpPr>
        <p:spPr>
          <a:xfrm>
            <a:off x="29028" y="21633"/>
            <a:ext cx="70358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2. Regression coefficients of polynomial functions of response surface for RGR of male and female gametophytes at Iwate (IWT), Tokushima (TKS), and Kagoshima (KGS).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441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0</TotalTime>
  <Words>473</Words>
  <Application>Microsoft Macintosh PowerPoint</Application>
  <PresentationFormat>A4 210 x 297 mm</PresentationFormat>
  <Paragraphs>29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ichi SATO</dc:creator>
  <cp:lastModifiedBy>Yoichi SATO</cp:lastModifiedBy>
  <cp:revision>5</cp:revision>
  <dcterms:created xsi:type="dcterms:W3CDTF">2020-06-28T00:04:57Z</dcterms:created>
  <dcterms:modified xsi:type="dcterms:W3CDTF">2020-08-15T11:01:58Z</dcterms:modified>
</cp:coreProperties>
</file>